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66" r:id="rId2"/>
    <p:sldId id="301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FFCCFF"/>
    <a:srgbClr val="A466E8"/>
    <a:srgbClr val="F62402"/>
    <a:srgbClr val="81E1FF"/>
    <a:srgbClr val="64BBFF"/>
    <a:srgbClr val="0066FF"/>
    <a:srgbClr val="FFB1D4"/>
    <a:srgbClr val="B86BE8"/>
    <a:srgbClr val="EA8B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259" autoAdjust="0"/>
    <p:restoredTop sz="94756"/>
  </p:normalViewPr>
  <p:slideViewPr>
    <p:cSldViewPr snapToGrid="0" snapToObjects="1">
      <p:cViewPr varScale="1">
        <p:scale>
          <a:sx n="55" d="100"/>
          <a:sy n="55" d="100"/>
        </p:scale>
        <p:origin x="2196" y="84"/>
      </p:cViewPr>
      <p:guideLst>
        <p:guide orient="horz" pos="2880"/>
        <p:guide pos="2160"/>
      </p:guideLst>
    </p:cSldViewPr>
  </p:slideViewPr>
  <p:notesTextViewPr>
    <p:cViewPr>
      <p:scale>
        <a:sx n="55" d="100"/>
        <a:sy n="55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5255E-8605-3E43-8FE9-7245B3B711D1}" type="datetimeFigureOut">
              <a:rPr lang="en-US" smtClean="0"/>
              <a:t>11/18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2CED0B-E5A3-B546-AA01-0C13C12F229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1986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2CED0B-E5A3-B546-AA01-0C13C12F2293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8097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0C1BB-AA52-B048-B3A3-2E0DCD07DBAA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1250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1F8BF6-B504-8544-833C-16673C6A7137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7765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6A9E6B-F562-8C4F-BC58-49F5F51DFA96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9231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440D8-65C8-5B40-98CE-EF4E8A9006DF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34540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E7A92-3073-4E4F-BC05-89432EB9E090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7342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EC18D-1ED1-B24D-B21B-EA27D97E7ABC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297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14B051-3829-FE4A-A5A4-DF0FEACD6319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2504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73BD-3B49-B040-B8A8-695B4B571736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29365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B5032-A729-7B48-A624-BFE22A8E8458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6928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25F85-7E5D-A14C-9BDE-C26BF4F503C5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1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03E4D-2766-874E-8C73-7B0A6F0AD223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sha Melia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12666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EE3C40-833D-5447-901A-C1C9FF365CAB}" type="datetime1">
              <a:rPr lang="en-US" smtClean="0"/>
              <a:t>11/18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dirty="0"/>
              <a:t>Tisha Melia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E92B6-DB3E-D746-A8FF-4331076CD7F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149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Z:\dos\waxman-lab\DO\genotype\script\combined_arrays_subset\fig\combined_collage_eqtl\UNC4561393_all\ncRNA_inter_chr4_3011_eqtl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117978"/>
            <a:ext cx="68580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Z:\dos\waxman-lab\DO\genotype\script\combined_arrays_subset\fig\combined_collage_eqtl\UNC4561393_all\Ppp1r3a_eqtl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4591" y="2493700"/>
            <a:ext cx="68580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Z:\dos\waxman-lab\DO\genotype\script\combined_arrays_subset\fig\combined_collage_eqtl\UNC4561393_all\Zbtb7c_eqtl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724146"/>
            <a:ext cx="68580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Z:\dos\waxman-lab\DO\genotype\script\combined_arrays_subset\fig\combined_collage_eqtl\UNC4561393_all\Gabra3_eqtl.pn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4591" y="888641"/>
            <a:ext cx="6858000" cy="137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5925918" y="-10197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8A Fig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 flipH="1">
            <a:off x="586740" y="1619362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H="1">
            <a:off x="556260" y="3054228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flipH="1">
            <a:off x="571500" y="4715521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H="1">
            <a:off x="586740" y="6293740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08660" y="304780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002280" y="304780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208413" y="311274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205480" y="660380"/>
            <a:ext cx="716478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/>
              <a:t>Gabra3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3145379" y="2266593"/>
            <a:ext cx="798617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/>
              <a:t>Ppp1r3a</a:t>
            </a:r>
            <a:endParaRPr lang="en-US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2556371" y="3862757"/>
            <a:ext cx="1976631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/>
              <a:t>ncRNA_inter_chr4_3011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3194286" y="5468924"/>
            <a:ext cx="684098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/>
              <a:t>Zbtb7c</a:t>
            </a:r>
            <a:endParaRPr lang="en-US" sz="1400" dirty="0"/>
          </a:p>
        </p:txBody>
      </p:sp>
      <p:cxnSp>
        <p:nvCxnSpPr>
          <p:cNvPr id="19" name="Straight Arrow Connector 18"/>
          <p:cNvCxnSpPr/>
          <p:nvPr/>
        </p:nvCxnSpPr>
        <p:spPr>
          <a:xfrm flipH="1">
            <a:off x="2005809" y="6212161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2074389" y="6060518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ci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56492" y="6114450"/>
            <a:ext cx="5005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trans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486050"/>
            <a:ext cx="6858000" cy="1371600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2344722" y="7137009"/>
            <a:ext cx="2159374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ncRNA_inter_chr18_14656</a:t>
            </a:r>
          </a:p>
        </p:txBody>
      </p:sp>
      <p:cxnSp>
        <p:nvCxnSpPr>
          <p:cNvPr id="23" name="Straight Arrow Connector 22"/>
          <p:cNvCxnSpPr/>
          <p:nvPr/>
        </p:nvCxnSpPr>
        <p:spPr>
          <a:xfrm flipH="1">
            <a:off x="588436" y="8271522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751971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69037"/>
            <a:ext cx="6858000" cy="13716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28541"/>
            <a:ext cx="6858000" cy="13716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306209"/>
            <a:ext cx="6858000" cy="13716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947616"/>
            <a:ext cx="6858000" cy="13716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29503"/>
            <a:ext cx="6858000" cy="13716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708660" y="304780"/>
            <a:ext cx="1024456" cy="305089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All Sampl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002280" y="304780"/>
            <a:ext cx="1204176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ale Sample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208413" y="311274"/>
            <a:ext cx="1361783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Female Sample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205480" y="660380"/>
            <a:ext cx="634404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 err="1"/>
              <a:t>Gabrq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3145379" y="2293097"/>
            <a:ext cx="643125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Timd2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264650" y="3998432"/>
            <a:ext cx="580608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/>
              <a:t>Gria4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3219958" y="5629055"/>
            <a:ext cx="669992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/>
              <a:t>Mrap2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2895690" y="7321726"/>
            <a:ext cx="1324402" cy="30777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400"/>
              <a:t>5730507C01Rik</a:t>
            </a:r>
            <a:endParaRPr lang="en-US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5792940" y="-25400"/>
            <a:ext cx="853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8B Fig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586740" y="1619362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556260" y="3291294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H="1">
            <a:off x="571500" y="4715521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H="1">
            <a:off x="586740" y="6293740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H="1">
            <a:off x="588436" y="8271522"/>
            <a:ext cx="137160" cy="81579"/>
          </a:xfrm>
          <a:prstGeom prst="straightConnector1">
            <a:avLst/>
          </a:prstGeom>
          <a:ln w="127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1962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90</TotalTime>
  <Words>37</Words>
  <Application>Microsoft Office PowerPoint</Application>
  <PresentationFormat>On-screen Show (4:3)</PresentationFormat>
  <Paragraphs>2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ia, Tisha</dc:creator>
  <cp:lastModifiedBy>sathiya vikram</cp:lastModifiedBy>
  <cp:revision>360</cp:revision>
  <cp:lastPrinted>2017-11-21T17:42:59Z</cp:lastPrinted>
  <dcterms:created xsi:type="dcterms:W3CDTF">2017-09-02T16:40:31Z</dcterms:created>
  <dcterms:modified xsi:type="dcterms:W3CDTF">2020-11-18T08:08:03Z</dcterms:modified>
</cp:coreProperties>
</file>